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9EBF5"/>
    <a:srgbClr val="CFD5EA"/>
    <a:srgbClr val="4472C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B301B821-A1FF-4177-AEE7-76D212191A09}" styleName="中間スタイル 1 - アクセント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1">
              <a:tint val="20000"/>
            </a:schemeClr>
          </a:solidFill>
        </a:fill>
      </a:tcStyle>
    </a:band1H>
    <a:band1V>
      <a:tcStyle>
        <a:tcBdr/>
        <a:fill>
          <a:solidFill>
            <a:schemeClr val="accent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Row>
  </a:tblStyle>
  <a:tblStyle styleId="{6E25E649-3F16-4E02-A733-19D2CDBF48F0}" styleName="中間スタイル 3 - アクセント 1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000" autoAdjust="0"/>
    <p:restoredTop sz="94660"/>
  </p:normalViewPr>
  <p:slideViewPr>
    <p:cSldViewPr snapToGrid="0">
      <p:cViewPr varScale="1">
        <p:scale>
          <a:sx n="48" d="100"/>
          <a:sy n="48" d="100"/>
        </p:scale>
        <p:origin x="2190" y="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926AD9-AAD8-4521-9570-E9EB547DCAD8}" type="datetimeFigureOut">
              <a:rPr kumimoji="1" lang="ja-JP" altLang="en-US" smtClean="0"/>
              <a:t>2024/8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E3AFA-A064-427F-9B25-5783C38C743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760196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926AD9-AAD8-4521-9570-E9EB547DCAD8}" type="datetimeFigureOut">
              <a:rPr kumimoji="1" lang="ja-JP" altLang="en-US" smtClean="0"/>
              <a:t>2024/8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E3AFA-A064-427F-9B25-5783C38C743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81886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926AD9-AAD8-4521-9570-E9EB547DCAD8}" type="datetimeFigureOut">
              <a:rPr kumimoji="1" lang="ja-JP" altLang="en-US" smtClean="0"/>
              <a:t>2024/8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E3AFA-A064-427F-9B25-5783C38C743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479389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926AD9-AAD8-4521-9570-E9EB547DCAD8}" type="datetimeFigureOut">
              <a:rPr kumimoji="1" lang="ja-JP" altLang="en-US" smtClean="0"/>
              <a:t>2024/8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E3AFA-A064-427F-9B25-5783C38C743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533873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926AD9-AAD8-4521-9570-E9EB547DCAD8}" type="datetimeFigureOut">
              <a:rPr kumimoji="1" lang="ja-JP" altLang="en-US" smtClean="0"/>
              <a:t>2024/8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E3AFA-A064-427F-9B25-5783C38C743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052652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926AD9-AAD8-4521-9570-E9EB547DCAD8}" type="datetimeFigureOut">
              <a:rPr kumimoji="1" lang="ja-JP" altLang="en-US" smtClean="0"/>
              <a:t>2024/8/2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E3AFA-A064-427F-9B25-5783C38C743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857806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926AD9-AAD8-4521-9570-E9EB547DCAD8}" type="datetimeFigureOut">
              <a:rPr kumimoji="1" lang="ja-JP" altLang="en-US" smtClean="0"/>
              <a:t>2024/8/2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E3AFA-A064-427F-9B25-5783C38C743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810276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926AD9-AAD8-4521-9570-E9EB547DCAD8}" type="datetimeFigureOut">
              <a:rPr kumimoji="1" lang="ja-JP" altLang="en-US" smtClean="0"/>
              <a:t>2024/8/2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E3AFA-A064-427F-9B25-5783C38C743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703183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926AD9-AAD8-4521-9570-E9EB547DCAD8}" type="datetimeFigureOut">
              <a:rPr kumimoji="1" lang="ja-JP" altLang="en-US" smtClean="0"/>
              <a:t>2024/8/2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E3AFA-A064-427F-9B25-5783C38C743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611318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926AD9-AAD8-4521-9570-E9EB547DCAD8}" type="datetimeFigureOut">
              <a:rPr kumimoji="1" lang="ja-JP" altLang="en-US" smtClean="0"/>
              <a:t>2024/8/2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E3AFA-A064-427F-9B25-5783C38C743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265450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926AD9-AAD8-4521-9570-E9EB547DCAD8}" type="datetimeFigureOut">
              <a:rPr kumimoji="1" lang="ja-JP" altLang="en-US" smtClean="0"/>
              <a:t>2024/8/2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E3AFA-A064-427F-9B25-5783C38C743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753862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6926AD9-AAD8-4521-9570-E9EB547DCAD8}" type="datetimeFigureOut">
              <a:rPr kumimoji="1" lang="ja-JP" altLang="en-US" smtClean="0"/>
              <a:t>2024/8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95E3AFA-A064-427F-9B25-5783C38C743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850642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3">
            <a:extLst>
              <a:ext uri="{FF2B5EF4-FFF2-40B4-BE49-F238E27FC236}">
                <a16:creationId xmlns:a16="http://schemas.microsoft.com/office/drawing/2014/main" id="{CEB85E77-04D6-0E02-4ECC-DEEA4B763E2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15663773"/>
              </p:ext>
            </p:extLst>
          </p:nvPr>
        </p:nvGraphicFramePr>
        <p:xfrm>
          <a:off x="747704" y="1128686"/>
          <a:ext cx="5328000" cy="70459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304261">
                  <a:extLst>
                    <a:ext uri="{9D8B030D-6E8A-4147-A177-3AD203B41FA5}">
                      <a16:colId xmlns:a16="http://schemas.microsoft.com/office/drawing/2014/main" val="3346788916"/>
                    </a:ext>
                  </a:extLst>
                </a:gridCol>
                <a:gridCol w="1359739">
                  <a:extLst>
                    <a:ext uri="{9D8B030D-6E8A-4147-A177-3AD203B41FA5}">
                      <a16:colId xmlns:a16="http://schemas.microsoft.com/office/drawing/2014/main" val="2801631884"/>
                    </a:ext>
                  </a:extLst>
                </a:gridCol>
                <a:gridCol w="1332000">
                  <a:extLst>
                    <a:ext uri="{9D8B030D-6E8A-4147-A177-3AD203B41FA5}">
                      <a16:colId xmlns:a16="http://schemas.microsoft.com/office/drawing/2014/main" val="1985588291"/>
                    </a:ext>
                  </a:extLst>
                </a:gridCol>
                <a:gridCol w="1332000">
                  <a:extLst>
                    <a:ext uri="{9D8B030D-6E8A-4147-A177-3AD203B41FA5}">
                      <a16:colId xmlns:a16="http://schemas.microsoft.com/office/drawing/2014/main" val="4228583807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Segment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 err="1"/>
                        <a:t>ATTRwt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 err="1"/>
                        <a:t>ATTRv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4472C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5445479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b="1" dirty="0"/>
                        <a:t>Base</a:t>
                      </a:r>
                      <a:endParaRPr kumimoji="1" lang="ja-JP" altLang="en-US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412±49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287; 1458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CFD5E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2839505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2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456±111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320; 1551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E9EBF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8238573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3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448±63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399; 1475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CFD5E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6639702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4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469±63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333; 1580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E9EBF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2272986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5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458±68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271; 1586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CFD5E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7317172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6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413±61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306; 1547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E9EBF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0872481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b="1" dirty="0"/>
                        <a:t>Mid-ventricle</a:t>
                      </a:r>
                      <a:endParaRPr kumimoji="1" lang="ja-JP" altLang="en-US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430±121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258; 1425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CFD5E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8778683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2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447±90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311; 1525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E9EBF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9348871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3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457±86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352; 1564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CFD5E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085658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4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432±94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352; 1462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E9EBF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3247375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5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411±99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350; 1422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CFD5E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1760862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6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406±113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351; 1427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E9EBF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80968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b="1" dirty="0"/>
                        <a:t>Apex</a:t>
                      </a:r>
                      <a:endParaRPr kumimoji="1" lang="ja-JP" altLang="en-US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423±119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279; 1523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CFD5E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1978349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2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449±109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388; 1515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E9EBF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5306094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3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460±101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390; 1573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CFD5E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3779486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4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431±113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370; 1476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E9EBF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9885246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5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407±108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318; 1508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CFD5E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5727409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6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416±103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294; 1569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E9EBF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89065845"/>
                  </a:ext>
                </a:extLst>
              </a:tr>
            </a:tbl>
          </a:graphicData>
        </a:graphic>
      </p:graphicFrame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21CBEC99-AF33-505A-C0CE-539DEDABDCE4}"/>
              </a:ext>
            </a:extLst>
          </p:cNvPr>
          <p:cNvSpPr txBox="1"/>
          <p:nvPr/>
        </p:nvSpPr>
        <p:spPr>
          <a:xfrm>
            <a:off x="747702" y="8367717"/>
            <a:ext cx="5328001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Data are presented as mean (</a:t>
            </a:r>
            <a:r>
              <a:rPr kumimoji="1"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ms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kumimoji="1" lang="en-US" altLang="ja-JP" sz="14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± standard deviation for </a:t>
            </a:r>
            <a:r>
              <a:rPr kumimoji="1" lang="en-US" altLang="ja-JP" sz="14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TTRwt</a:t>
            </a:r>
            <a:r>
              <a:rPr kumimoji="1" lang="en-US" altLang="ja-JP" sz="14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n=43) and as absolute value (</a:t>
            </a:r>
            <a:r>
              <a:rPr kumimoji="1" lang="en-US" altLang="ja-JP" sz="14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s</a:t>
            </a:r>
            <a:r>
              <a:rPr kumimoji="1" lang="en-US" altLang="ja-JP" sz="14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for </a:t>
            </a:r>
            <a:r>
              <a:rPr kumimoji="1" lang="en-US" altLang="ja-JP" sz="14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TTRv</a:t>
            </a:r>
            <a:r>
              <a:rPr kumimoji="1" lang="en-US" altLang="ja-JP" sz="14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</a:t>
            </a:r>
            <a:r>
              <a:rPr lang="en-US" altLang="ja-JP" sz="1400" kern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ゴシック" panose="020B0400000000000000" pitchFamily="50" charset="-128"/>
              </a:rPr>
              <a:t>heterozygous c.424G&gt;A p.Val142Ile;</a:t>
            </a:r>
            <a:r>
              <a:rPr lang="en-US" altLang="ja-JP" sz="1400" kern="0" dirty="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</a:rPr>
              <a:t> </a:t>
            </a:r>
            <a:r>
              <a:rPr lang="en-US" altLang="ja-JP" sz="1400" kern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ゴシック" panose="020B0400000000000000" pitchFamily="50" charset="-128"/>
              </a:rPr>
              <a:t>heterozygous c.148G&gt;A p.Val50Met</a:t>
            </a:r>
            <a:r>
              <a:rPr kumimoji="1" lang="en-US" altLang="ja-JP" sz="14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109C2C04-D6EB-5B95-FB00-7BAF75F7188D}"/>
              </a:ext>
            </a:extLst>
          </p:cNvPr>
          <p:cNvSpPr txBox="1"/>
          <p:nvPr/>
        </p:nvSpPr>
        <p:spPr>
          <a:xfrm>
            <a:off x="3905250" y="47618"/>
            <a:ext cx="28230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upplemental Table 2. Tsuruda T, et al.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B2CEB4C1-641D-D9F4-2B78-A17F28581C05}"/>
              </a:ext>
            </a:extLst>
          </p:cNvPr>
          <p:cNvSpPr txBox="1"/>
          <p:nvPr/>
        </p:nvSpPr>
        <p:spPr>
          <a:xfrm>
            <a:off x="728138" y="581018"/>
            <a:ext cx="538230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Comparison of native T1 between </a:t>
            </a:r>
            <a:r>
              <a:rPr kumimoji="1" lang="en-US" altLang="ja-JP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ATTRwt</a:t>
            </a:r>
            <a:r>
              <a:rPr kumimoji="1"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kumimoji="1" lang="en-US" altLang="ja-JP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ATTRv</a:t>
            </a:r>
            <a:endParaRPr kumimoji="1"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29997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テーマ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7</TotalTime>
  <Words>162</Words>
  <Application>Microsoft Office PowerPoint</Application>
  <PresentationFormat>ワイド画面</PresentationFormat>
  <Paragraphs>6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敏博 鶴田</dc:creator>
  <cp:lastModifiedBy>敏博 鶴田</cp:lastModifiedBy>
  <cp:revision>34</cp:revision>
  <dcterms:created xsi:type="dcterms:W3CDTF">2024-08-14T23:23:01Z</dcterms:created>
  <dcterms:modified xsi:type="dcterms:W3CDTF">2024-08-21T02:26:16Z</dcterms:modified>
</cp:coreProperties>
</file>